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D99C6-CF0E-4627-BB68-20B8B4E438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16096-E88C-4B9C-B8AA-61988ABB1F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32C0A-68D0-4B07-85A8-188E8111B3D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4DB41-6960-4696-AC13-102D8334EC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C75B5-0C84-4E6C-B8A4-AEC68EAC9F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D7764-A44A-4F38-8A87-DFFE4CD76E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62362-59EF-4A9E-A327-7C0FA69B9A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5D5CD-4C94-4A7E-B535-4D33AB69EE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92565-ADA8-4145-87E3-F056DE99F2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348A0-9812-4C05-BA33-2792A9A269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AAD52-99AC-4E89-90C6-C7D8AE194D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00AFD-62BF-46C7-A789-0F21546757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A9571C-ACFE-41E8-8815-5F78D977E1F0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9" descr="F:\Gyan Office-Laptop\DGR Publications\Tanmoy TC  New\Plos\Figure 5 S3.tif"/>
          <p:cNvPicPr/>
          <p:nvPr/>
        </p:nvPicPr>
        <p:blipFill>
          <a:blip r:embed="rId1"/>
          <a:stretch/>
        </p:blipFill>
        <p:spPr>
          <a:xfrm>
            <a:off x="549360" y="649440"/>
            <a:ext cx="8045280" cy="555912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6"/>
          <p:cNvSpPr/>
          <p:nvPr/>
        </p:nvSpPr>
        <p:spPr>
          <a:xfrm>
            <a:off x="380880" y="6171480"/>
            <a:ext cx="8534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3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otal Chlorophyll Content of three transgenic lines and W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Under various levels of PEG (A) and NaCl (B) with increasing days of stress exposure (refer to Figure 1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4T18:09:22Z</dcterms:created>
  <dc:creator>Dr. Radhakrishnan</dc:creator>
  <dc:description/>
  <dc:language>en-US</dc:language>
  <cp:lastModifiedBy>Dr. Radhakrishnan</cp:lastModifiedBy>
  <dcterms:modified xsi:type="dcterms:W3CDTF">2014-11-24T18:14:47Z</dcterms:modified>
  <cp:revision>3</cp:revision>
  <dc:subject/>
  <dc:title>Slide 1</dc:title>
</cp:coreProperties>
</file>